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87" autoAdjust="0"/>
    <p:restoredTop sz="92623" autoAdjust="0"/>
  </p:normalViewPr>
  <p:slideViewPr>
    <p:cSldViewPr snapToGrid="0">
      <p:cViewPr>
        <p:scale>
          <a:sx n="75" d="100"/>
          <a:sy n="75" d="100"/>
        </p:scale>
        <p:origin x="54" y="28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468476-152A-4C0D-A99B-B3A556AD365F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BDA8F9-A0F6-4FC6-9DE9-54BA3C1D5D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35979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23.10.31. </a:t>
            </a:r>
            <a:r>
              <a:rPr lang="ko-KR" altLang="en-US" dirty="0"/>
              <a:t>수정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BDA8F9-A0F6-4FC6-9DE9-54BA3C1D5D40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51004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070239F-C5DB-5FDB-AA94-8CF2B16E8D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548D72F-4DEC-61DD-02E5-3E8110BFF7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F19442A-B204-5D4A-21A3-537656597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8FFB89C-B831-2997-21F3-80FD442CF9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1817B58-96FA-AB97-EE11-6E467E681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3653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B8260B9-631B-BD42-BCE4-7FC9E062D2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F67F432-28F5-7384-946B-4BB7C06EF5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FCC8944-CDEC-F2C3-8E36-E3D9EBCB4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8AFD580-6627-6B5E-A231-7CFE4FB704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8B9CA32-7E8A-F50C-2645-83526E899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2110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2F599395-2DD1-B27B-97C0-E3BDE5D58B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87E20A9-9164-58D1-C040-0F363A1252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7BF5D57-3252-5C48-B9B6-03A32A7AF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FFB09CF-CA99-1831-B5ED-0F06F7471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0360C4A-90DA-BE0B-35B7-23FD2A876F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5189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81F71B1-60FA-58E7-0438-49ECE23F6E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8911082-7904-354C-51A2-3BDCFD19EE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FC5C03F-8E7F-0F56-2A35-54F25FE35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37C113F-7A15-FE64-A4B7-1B3BB9C07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E2205ED-A472-559C-F3EC-4640B3572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02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8D375E9-DC43-56E3-89FD-0E9F8A17C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528E492-A17E-2DC8-8F17-4890EC009D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831802B-DDB1-E5E8-C4F2-0DF9707E9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FD03377-2478-1498-0EC1-D56402FED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3A70369-43EA-2A8D-10B2-E94FE20A1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0016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3004FAC-F78A-B1A5-DB09-474429CF58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5B1C5B4-FB5A-1EA7-1701-26F41A5329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19338F4-8C15-FD9C-9AC2-40FDF89FDB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6E56EDD-AF04-BE8B-C75D-6E1200222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FCF2C2B-1A86-F5EE-7053-0D13095C2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76C2F52-2B67-4EE2-2291-48F80A5D8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6678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1108175-9176-F573-9AAC-E6A418A680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4E7B223-2261-609A-16D6-E32BE2E52A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844A78B-F686-4B26-CB39-99C109DE76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C280434-DC3B-8748-8C35-20D3F2FE8E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F4462879-2046-9F2E-B9CB-DE56531869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6E380AB1-0E79-E607-F26B-57C1B8F4C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D73522E2-D8AB-19AD-F15E-CB0241853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BA98D7F-E281-70B0-0899-50A4A31F5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45808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9BDD502-1A71-8BE1-720A-25CF0C6EF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0EC4905-8067-E57E-BAC7-DFC89EB5B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CC60792-9A55-716B-0D28-8361C9BD3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1D97CF7-BE9D-98F3-BEC5-43C0E8160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0194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CEBB8188-831B-3FED-8F49-315602E359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CBFDAA2C-0266-0CD8-3900-7EABFBCB9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55C360B-CD0A-BC37-92D8-1D3B9B774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2233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7F5A866-971F-9F9B-2F61-C816ABBFF5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7AF2948-6862-13A3-8F0F-E6E05C1135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836DF9F-6E26-B7E7-D325-BABADC179A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06DE61F-108A-DBAD-515A-919A16490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45F18B5-90C3-004A-65A0-762AAB4B8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A2CF116-DCE4-3B67-5DC0-2604C09F1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8186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321E4BB-9488-D0E7-5BBB-1730DC4104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F5C4993-EBE6-76ED-ED50-B6FB1BCF8A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1AABCA3-ABEC-3C69-243E-5BDE5BE10F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7300CBA-65C6-770D-DC42-633BAC229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0BCCE20-18C5-CF78-9303-E805DE59F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957DAD7-704C-1E95-1BC9-F3379E9E32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8431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7815771-2550-017F-996D-A2B60E4310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A712985-228E-45AD-13E9-3C92DDDE04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0EC2468-E497-1070-6A4E-F2614A168F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1EDDB8-1369-494C-BBB7-05986F3EE684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9229112-61FB-79C8-72C4-A3CB114CB7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CC1F468-85E4-F44D-EBDD-63BC60BAFB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2CA506-F777-4D09-962F-AF96CF2B57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6609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>
            <a:extLst>
              <a:ext uri="{FF2B5EF4-FFF2-40B4-BE49-F238E27FC236}">
                <a16:creationId xmlns:a16="http://schemas.microsoft.com/office/drawing/2014/main" id="{3C39A051-B6E4-46CA-A4AB-6973B23E392E}"/>
              </a:ext>
            </a:extLst>
          </p:cNvPr>
          <p:cNvGrpSpPr/>
          <p:nvPr/>
        </p:nvGrpSpPr>
        <p:grpSpPr>
          <a:xfrm>
            <a:off x="562830" y="-1125084"/>
            <a:ext cx="9317770" cy="9322925"/>
            <a:chOff x="562830" y="-1125084"/>
            <a:chExt cx="9317770" cy="9322925"/>
          </a:xfrm>
        </p:grpSpPr>
        <p:grpSp>
          <p:nvGrpSpPr>
            <p:cNvPr id="79" name="그룹 78">
              <a:extLst>
                <a:ext uri="{FF2B5EF4-FFF2-40B4-BE49-F238E27FC236}">
                  <a16:creationId xmlns:a16="http://schemas.microsoft.com/office/drawing/2014/main" id="{B74A6824-7297-4C45-B3A0-91B6BC7C8450}"/>
                </a:ext>
              </a:extLst>
            </p:cNvPr>
            <p:cNvGrpSpPr/>
            <p:nvPr/>
          </p:nvGrpSpPr>
          <p:grpSpPr>
            <a:xfrm>
              <a:off x="3810726" y="599871"/>
              <a:ext cx="2520000" cy="593289"/>
              <a:chOff x="178235" y="2715877"/>
              <a:chExt cx="1987200" cy="680882"/>
            </a:xfrm>
          </p:grpSpPr>
          <p:sp>
            <p:nvSpPr>
              <p:cNvPr id="80" name="직사각형 13">
                <a:extLst>
                  <a:ext uri="{FF2B5EF4-FFF2-40B4-BE49-F238E27FC236}">
                    <a16:creationId xmlns:a16="http://schemas.microsoft.com/office/drawing/2014/main" id="{1DAE235E-8711-41F1-A5E8-4A7DD17C52FF}"/>
                  </a:ext>
                </a:extLst>
              </p:cNvPr>
              <p:cNvSpPr/>
              <p:nvPr/>
            </p:nvSpPr>
            <p:spPr>
              <a:xfrm>
                <a:off x="178235" y="2715877"/>
                <a:ext cx="1987200" cy="674704"/>
              </a:xfrm>
              <a:prstGeom prst="flowChartAlternateProcess">
                <a:avLst/>
              </a:prstGeom>
              <a:noFill/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3C78D58D-9B8F-4F15-8068-AE87D2D8AAB1}"/>
                  </a:ext>
                </a:extLst>
              </p:cNvPr>
              <p:cNvSpPr txBox="1"/>
              <p:nvPr/>
            </p:nvSpPr>
            <p:spPr>
              <a:xfrm>
                <a:off x="409447" y="2733394"/>
                <a:ext cx="1524776" cy="663365"/>
              </a:xfrm>
              <a:prstGeom prst="flowChartAlternateProcess">
                <a:avLst/>
              </a:prstGeom>
              <a:noFill/>
              <a:ln>
                <a:noFill/>
              </a:ln>
            </p:spPr>
            <p:txBody>
              <a:bodyPr wrap="none" rtlCol="0" anchor="ctr">
                <a:noAutofit/>
              </a:bodyPr>
              <a:lstStyle/>
              <a:p>
                <a:pPr algn="ctr"/>
                <a:r>
                  <a:rPr lang="en-US" altLang="ko-KR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 items (1</a:t>
                </a:r>
                <a:r>
                  <a:rPr lang="en-US" altLang="ko-KR" sz="1800" dirty="0">
                    <a:effectLst/>
                    <a:latin typeface="Times New Roman" panose="02020603050405020304" pitchFamily="18" charset="0"/>
                    <a:ea typeface="함초롬바탕" panose="02030604000101010101" pitchFamily="18" charset="-127"/>
                  </a:rPr>
                  <a:t>–</a:t>
                </a:r>
                <a:r>
                  <a:rPr lang="en-US" altLang="ko-KR" sz="1600" dirty="0">
                    <a:effectLst/>
                    <a:latin typeface="Times New Roman" panose="02020603050405020304" pitchFamily="18" charset="0"/>
                    <a:ea typeface="함초롬바탕" panose="02030604000101010101" pitchFamily="18" charset="-127"/>
                    <a:cs typeface="Times New Roman" panose="02020603050405020304" pitchFamily="18" charset="0"/>
                  </a:rPr>
                  <a:t>16, 20)</a:t>
                </a:r>
                <a:endParaRPr lang="ko-KR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8" name="그룹 127">
              <a:extLst>
                <a:ext uri="{FF2B5EF4-FFF2-40B4-BE49-F238E27FC236}">
                  <a16:creationId xmlns:a16="http://schemas.microsoft.com/office/drawing/2014/main" id="{4C4C0C70-073C-4CAB-BBAA-46D0D8284715}"/>
                </a:ext>
              </a:extLst>
            </p:cNvPr>
            <p:cNvGrpSpPr/>
            <p:nvPr/>
          </p:nvGrpSpPr>
          <p:grpSpPr>
            <a:xfrm>
              <a:off x="3810726" y="-1125084"/>
              <a:ext cx="2520000" cy="593289"/>
              <a:chOff x="178235" y="2715877"/>
              <a:chExt cx="1987200" cy="680882"/>
            </a:xfrm>
          </p:grpSpPr>
          <p:sp>
            <p:nvSpPr>
              <p:cNvPr id="130" name="직사각형 13">
                <a:extLst>
                  <a:ext uri="{FF2B5EF4-FFF2-40B4-BE49-F238E27FC236}">
                    <a16:creationId xmlns:a16="http://schemas.microsoft.com/office/drawing/2014/main" id="{910A9F2A-923E-4052-B69E-3B96B281CBCA}"/>
                  </a:ext>
                </a:extLst>
              </p:cNvPr>
              <p:cNvSpPr/>
              <p:nvPr/>
            </p:nvSpPr>
            <p:spPr>
              <a:xfrm>
                <a:off x="178235" y="2715877"/>
                <a:ext cx="1987200" cy="674704"/>
              </a:xfrm>
              <a:prstGeom prst="flowChartAlternateProcess">
                <a:avLst/>
              </a:prstGeom>
              <a:noFill/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005CF08E-C99F-4484-9C2C-1B496A29A386}"/>
                  </a:ext>
                </a:extLst>
              </p:cNvPr>
              <p:cNvSpPr txBox="1"/>
              <p:nvPr/>
            </p:nvSpPr>
            <p:spPr>
              <a:xfrm>
                <a:off x="409447" y="2733394"/>
                <a:ext cx="1524776" cy="663365"/>
              </a:xfrm>
              <a:prstGeom prst="flowChartAlternateProcess">
                <a:avLst/>
              </a:prstGeom>
              <a:noFill/>
              <a:ln>
                <a:noFill/>
              </a:ln>
            </p:spPr>
            <p:txBody>
              <a:bodyPr wrap="none" rtlCol="0" anchor="ctr">
                <a:noAutofit/>
              </a:bodyPr>
              <a:lstStyle/>
              <a:p>
                <a:pPr algn="ctr"/>
                <a:r>
                  <a:rPr lang="en-US" altLang="ko-KR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1 items (1</a:t>
                </a:r>
                <a:r>
                  <a:rPr lang="en-US" altLang="ko-KR" sz="1800" dirty="0">
                    <a:effectLst/>
                    <a:latin typeface="Times New Roman" panose="02020603050405020304" pitchFamily="18" charset="0"/>
                    <a:ea typeface="함초롬바탕" panose="02030604000101010101" pitchFamily="18" charset="-127"/>
                  </a:rPr>
                  <a:t>–21)</a:t>
                </a:r>
                <a:endParaRPr lang="ko-KR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32" name="직선 화살표 연결선 131">
              <a:extLst>
                <a:ext uri="{FF2B5EF4-FFF2-40B4-BE49-F238E27FC236}">
                  <a16:creationId xmlns:a16="http://schemas.microsoft.com/office/drawing/2014/main" id="{C97D90B5-B0B8-4D5F-B468-50A93A322F0B}"/>
                </a:ext>
              </a:extLst>
            </p:cNvPr>
            <p:cNvCxnSpPr>
              <a:cxnSpLocks/>
            </p:cNvCxnSpPr>
            <p:nvPr/>
          </p:nvCxnSpPr>
          <p:spPr>
            <a:xfrm>
              <a:off x="5059290" y="-520058"/>
              <a:ext cx="11437" cy="1080000"/>
            </a:xfrm>
            <a:prstGeom prst="straightConnector1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BC14565F-8A8D-4638-BD54-26AFFD2D1978}"/>
                </a:ext>
              </a:extLst>
            </p:cNvPr>
            <p:cNvSpPr txBox="1"/>
            <p:nvPr/>
          </p:nvSpPr>
          <p:spPr>
            <a:xfrm>
              <a:off x="5066828" y="-145346"/>
              <a:ext cx="4091686" cy="32029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ding items with low content validity (17</a:t>
              </a:r>
              <a:r>
                <a:rPr lang="en-US" altLang="ko-KR" sz="1400" kern="1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–19, 21</a:t>
              </a:r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7" name="직선 화살표 연결선 136">
              <a:extLst>
                <a:ext uri="{FF2B5EF4-FFF2-40B4-BE49-F238E27FC236}">
                  <a16:creationId xmlns:a16="http://schemas.microsoft.com/office/drawing/2014/main" id="{67F7CA8E-BC13-4A54-BBCD-B9728FC8DA0D}"/>
                </a:ext>
              </a:extLst>
            </p:cNvPr>
            <p:cNvCxnSpPr>
              <a:cxnSpLocks/>
            </p:cNvCxnSpPr>
            <p:nvPr/>
          </p:nvCxnSpPr>
          <p:spPr>
            <a:xfrm>
              <a:off x="5077748" y="1207033"/>
              <a:ext cx="11437" cy="1080000"/>
            </a:xfrm>
            <a:prstGeom prst="straightConnector1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92F74026-117A-4C54-A031-36531A55B606}"/>
                </a:ext>
              </a:extLst>
            </p:cNvPr>
            <p:cNvSpPr txBox="1"/>
            <p:nvPr/>
          </p:nvSpPr>
          <p:spPr>
            <a:xfrm>
              <a:off x="5097220" y="1396083"/>
              <a:ext cx="2753180" cy="37647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loratory factor analysis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" name="그룹 11">
              <a:extLst>
                <a:ext uri="{FF2B5EF4-FFF2-40B4-BE49-F238E27FC236}">
                  <a16:creationId xmlns:a16="http://schemas.microsoft.com/office/drawing/2014/main" id="{3458FF90-8EB1-42E5-B08C-F1A7586BCC96}"/>
                </a:ext>
              </a:extLst>
            </p:cNvPr>
            <p:cNvGrpSpPr/>
            <p:nvPr/>
          </p:nvGrpSpPr>
          <p:grpSpPr>
            <a:xfrm>
              <a:off x="2630469" y="2339666"/>
              <a:ext cx="1440000" cy="720000"/>
              <a:chOff x="7741010" y="5064578"/>
              <a:chExt cx="3596489" cy="958470"/>
            </a:xfrm>
          </p:grpSpPr>
          <p:sp>
            <p:nvSpPr>
              <p:cNvPr id="139" name="직사각형 13">
                <a:extLst>
                  <a:ext uri="{FF2B5EF4-FFF2-40B4-BE49-F238E27FC236}">
                    <a16:creationId xmlns:a16="http://schemas.microsoft.com/office/drawing/2014/main" id="{7B8C1C50-AE3E-437B-BDA7-5649451259C4}"/>
                  </a:ext>
                </a:extLst>
              </p:cNvPr>
              <p:cNvSpPr/>
              <p:nvPr/>
            </p:nvSpPr>
            <p:spPr>
              <a:xfrm>
                <a:off x="7741010" y="5244579"/>
                <a:ext cx="3596489" cy="778469"/>
              </a:xfrm>
              <a:prstGeom prst="rect">
                <a:avLst/>
              </a:prstGeom>
              <a:noFill/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직사각형 13">
                <a:extLst>
                  <a:ext uri="{FF2B5EF4-FFF2-40B4-BE49-F238E27FC236}">
                    <a16:creationId xmlns:a16="http://schemas.microsoft.com/office/drawing/2014/main" id="{8D2B50D4-90AA-4693-938F-452D64025923}"/>
                  </a:ext>
                </a:extLst>
              </p:cNvPr>
              <p:cNvSpPr/>
              <p:nvPr/>
            </p:nvSpPr>
            <p:spPr>
              <a:xfrm>
                <a:off x="8349756" y="5064578"/>
                <a:ext cx="2337718" cy="360000"/>
              </a:xfrm>
              <a:prstGeom prst="round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6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ctor 1</a:t>
                </a:r>
                <a:endParaRPr lang="ko-KR" altLang="en-US" sz="1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1" name="그룹 140">
              <a:extLst>
                <a:ext uri="{FF2B5EF4-FFF2-40B4-BE49-F238E27FC236}">
                  <a16:creationId xmlns:a16="http://schemas.microsoft.com/office/drawing/2014/main" id="{4E0A9A57-3AB6-4351-832D-FC6C63020D1C}"/>
                </a:ext>
              </a:extLst>
            </p:cNvPr>
            <p:cNvGrpSpPr/>
            <p:nvPr/>
          </p:nvGrpSpPr>
          <p:grpSpPr>
            <a:xfrm>
              <a:off x="4357748" y="2338233"/>
              <a:ext cx="1440000" cy="720000"/>
              <a:chOff x="7741010" y="5064578"/>
              <a:chExt cx="3596489" cy="958470"/>
            </a:xfrm>
          </p:grpSpPr>
          <p:sp>
            <p:nvSpPr>
              <p:cNvPr id="142" name="직사각형 13">
                <a:extLst>
                  <a:ext uri="{FF2B5EF4-FFF2-40B4-BE49-F238E27FC236}">
                    <a16:creationId xmlns:a16="http://schemas.microsoft.com/office/drawing/2014/main" id="{46EA77E6-9DA7-40AC-99DA-23FCB1915C59}"/>
                  </a:ext>
                </a:extLst>
              </p:cNvPr>
              <p:cNvSpPr/>
              <p:nvPr/>
            </p:nvSpPr>
            <p:spPr>
              <a:xfrm>
                <a:off x="7741010" y="5244579"/>
                <a:ext cx="3596489" cy="778469"/>
              </a:xfrm>
              <a:prstGeom prst="rect">
                <a:avLst/>
              </a:prstGeom>
              <a:noFill/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직사각형 13">
                <a:extLst>
                  <a:ext uri="{FF2B5EF4-FFF2-40B4-BE49-F238E27FC236}">
                    <a16:creationId xmlns:a16="http://schemas.microsoft.com/office/drawing/2014/main" id="{0948715E-A9E6-494C-81FF-E3541F1FC7F9}"/>
                  </a:ext>
                </a:extLst>
              </p:cNvPr>
              <p:cNvSpPr/>
              <p:nvPr/>
            </p:nvSpPr>
            <p:spPr>
              <a:xfrm>
                <a:off x="8349756" y="5064578"/>
                <a:ext cx="2337718" cy="360000"/>
              </a:xfrm>
              <a:prstGeom prst="round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6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ctor 2</a:t>
                </a:r>
                <a:endParaRPr lang="ko-KR" altLang="en-US" sz="1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4" name="그룹 143">
              <a:extLst>
                <a:ext uri="{FF2B5EF4-FFF2-40B4-BE49-F238E27FC236}">
                  <a16:creationId xmlns:a16="http://schemas.microsoft.com/office/drawing/2014/main" id="{543C57C5-774A-453D-AA52-F755D32DA1B8}"/>
                </a:ext>
              </a:extLst>
            </p:cNvPr>
            <p:cNvGrpSpPr/>
            <p:nvPr/>
          </p:nvGrpSpPr>
          <p:grpSpPr>
            <a:xfrm>
              <a:off x="6085027" y="2338233"/>
              <a:ext cx="1440000" cy="720000"/>
              <a:chOff x="7741010" y="5064578"/>
              <a:chExt cx="3596489" cy="958470"/>
            </a:xfrm>
          </p:grpSpPr>
          <p:sp>
            <p:nvSpPr>
              <p:cNvPr id="145" name="직사각형 13">
                <a:extLst>
                  <a:ext uri="{FF2B5EF4-FFF2-40B4-BE49-F238E27FC236}">
                    <a16:creationId xmlns:a16="http://schemas.microsoft.com/office/drawing/2014/main" id="{DD3C45E1-FDC9-4A92-AA08-4F4F2DC556A5}"/>
                  </a:ext>
                </a:extLst>
              </p:cNvPr>
              <p:cNvSpPr/>
              <p:nvPr/>
            </p:nvSpPr>
            <p:spPr>
              <a:xfrm>
                <a:off x="7741010" y="5244579"/>
                <a:ext cx="3596489" cy="778469"/>
              </a:xfrm>
              <a:prstGeom prst="rect">
                <a:avLst/>
              </a:prstGeom>
              <a:noFill/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직사각형 13">
                <a:extLst>
                  <a:ext uri="{FF2B5EF4-FFF2-40B4-BE49-F238E27FC236}">
                    <a16:creationId xmlns:a16="http://schemas.microsoft.com/office/drawing/2014/main" id="{A18C3DF5-4516-4E47-B4A8-9135E1B09E7A}"/>
                  </a:ext>
                </a:extLst>
              </p:cNvPr>
              <p:cNvSpPr/>
              <p:nvPr/>
            </p:nvSpPr>
            <p:spPr>
              <a:xfrm>
                <a:off x="8349756" y="5064578"/>
                <a:ext cx="2337718" cy="360000"/>
              </a:xfrm>
              <a:prstGeom prst="round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6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ctor 3</a:t>
                </a:r>
                <a:endParaRPr lang="ko-KR" altLang="en-US" sz="1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2F4E2606-CCA6-4F83-8A35-BB8BEF7927F0}"/>
                </a:ext>
              </a:extLst>
            </p:cNvPr>
            <p:cNvSpPr txBox="1"/>
            <p:nvPr/>
          </p:nvSpPr>
          <p:spPr>
            <a:xfrm>
              <a:off x="2985265" y="2622661"/>
              <a:ext cx="717343" cy="36121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pPr algn="ctr"/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ko-KR" sz="2000" kern="1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–</a:t>
              </a:r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ko-KR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A4BAC84E-5CB8-43D0-AC53-74D2E07F93A4}"/>
                </a:ext>
              </a:extLst>
            </p:cNvPr>
            <p:cNvSpPr txBox="1"/>
            <p:nvPr/>
          </p:nvSpPr>
          <p:spPr>
            <a:xfrm>
              <a:off x="4656763" y="2623504"/>
              <a:ext cx="864843" cy="36121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pPr algn="ctr"/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ko-KR" sz="1600" kern="1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0–</a:t>
              </a:r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lang="ko-KR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69097145-7170-4E94-A896-F38E658FD5F2}"/>
                </a:ext>
              </a:extLst>
            </p:cNvPr>
            <p:cNvSpPr txBox="1"/>
            <p:nvPr/>
          </p:nvSpPr>
          <p:spPr>
            <a:xfrm>
              <a:off x="6516065" y="2622661"/>
              <a:ext cx="577324" cy="36121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pPr algn="ctr"/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ko-KR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1" name="직선 화살표 연결선 150">
              <a:extLst>
                <a:ext uri="{FF2B5EF4-FFF2-40B4-BE49-F238E27FC236}">
                  <a16:creationId xmlns:a16="http://schemas.microsoft.com/office/drawing/2014/main" id="{03A46AAE-6799-470B-BCD4-72EA7E162ECB}"/>
                </a:ext>
              </a:extLst>
            </p:cNvPr>
            <p:cNvCxnSpPr>
              <a:cxnSpLocks/>
            </p:cNvCxnSpPr>
            <p:nvPr/>
          </p:nvCxnSpPr>
          <p:spPr>
            <a:xfrm>
              <a:off x="6842826" y="3058233"/>
              <a:ext cx="1007580" cy="294567"/>
            </a:xfrm>
            <a:prstGeom prst="bentConnector3">
              <a:avLst>
                <a:gd name="adj1" fmla="val -2939"/>
              </a:avLst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prstDash val="dash"/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B054BE8B-AD8A-4DA1-88EF-E45D31E1AD83}"/>
                </a:ext>
              </a:extLst>
            </p:cNvPr>
            <p:cNvSpPr txBox="1"/>
            <p:nvPr/>
          </p:nvSpPr>
          <p:spPr>
            <a:xfrm>
              <a:off x="7850400" y="3086804"/>
              <a:ext cx="2030200" cy="53199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ding item </a:t>
              </a:r>
            </a:p>
            <a:p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high uniqueness (20)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1" name="직선 화살표 연결선 150">
              <a:extLst>
                <a:ext uri="{FF2B5EF4-FFF2-40B4-BE49-F238E27FC236}">
                  <a16:creationId xmlns:a16="http://schemas.microsoft.com/office/drawing/2014/main" id="{9C5C60D0-C1CF-4D90-A7F6-A01040D2C65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5059007" y="554413"/>
              <a:ext cx="15642" cy="3475799"/>
            </a:xfrm>
            <a:prstGeom prst="bentConnector3">
              <a:avLst>
                <a:gd name="adj1" fmla="val -2273367"/>
              </a:avLst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headEnd type="triangle" w="lg" len="med"/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F3DD5EFC-E490-41E0-B462-84EDA2DA58C3}"/>
                </a:ext>
              </a:extLst>
            </p:cNvPr>
            <p:cNvSpPr txBox="1"/>
            <p:nvPr/>
          </p:nvSpPr>
          <p:spPr>
            <a:xfrm>
              <a:off x="5069847" y="3915705"/>
              <a:ext cx="2780553" cy="37647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-exploratory factor analysis  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2" name="직선 화살표 연결선 181">
              <a:extLst>
                <a:ext uri="{FF2B5EF4-FFF2-40B4-BE49-F238E27FC236}">
                  <a16:creationId xmlns:a16="http://schemas.microsoft.com/office/drawing/2014/main" id="{4D0B242D-B836-4BCF-B7FD-583A7CA948C2}"/>
                </a:ext>
              </a:extLst>
            </p:cNvPr>
            <p:cNvCxnSpPr>
              <a:cxnSpLocks/>
            </p:cNvCxnSpPr>
            <p:nvPr/>
          </p:nvCxnSpPr>
          <p:spPr>
            <a:xfrm>
              <a:off x="5091501" y="3071336"/>
              <a:ext cx="11437" cy="1440000"/>
            </a:xfrm>
            <a:prstGeom prst="straightConnector1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76DB5D1E-5682-423B-9DF8-899A308890DE}"/>
                </a:ext>
              </a:extLst>
            </p:cNvPr>
            <p:cNvSpPr txBox="1"/>
            <p:nvPr/>
          </p:nvSpPr>
          <p:spPr>
            <a:xfrm>
              <a:off x="5081754" y="3359112"/>
              <a:ext cx="1392056" cy="37647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verse coded (10</a:t>
              </a:r>
              <a:r>
                <a:rPr lang="en-US" altLang="ko-KR" sz="1400" kern="1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–</a:t>
              </a:r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)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4" name="직선 화살표 연결선 150">
              <a:extLst>
                <a:ext uri="{FF2B5EF4-FFF2-40B4-BE49-F238E27FC236}">
                  <a16:creationId xmlns:a16="http://schemas.microsoft.com/office/drawing/2014/main" id="{404B1850-FA38-4567-8389-C62DEC65BB4B}"/>
                </a:ext>
              </a:extLst>
            </p:cNvPr>
            <p:cNvCxnSpPr>
              <a:cxnSpLocks/>
              <a:stCxn id="139" idx="2"/>
            </p:cNvCxnSpPr>
            <p:nvPr/>
          </p:nvCxnSpPr>
          <p:spPr>
            <a:xfrm rot="16200000" flipH="1">
              <a:off x="3881946" y="2528189"/>
              <a:ext cx="675764" cy="1738718"/>
            </a:xfrm>
            <a:prstGeom prst="bentConnector2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headEnd type="none" w="lg" len="med"/>
              <a:tailEnd type="non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타원 48">
              <a:extLst>
                <a:ext uri="{FF2B5EF4-FFF2-40B4-BE49-F238E27FC236}">
                  <a16:creationId xmlns:a16="http://schemas.microsoft.com/office/drawing/2014/main" id="{F60C55EE-9713-47E9-AAF9-02C8B774CCEE}"/>
                </a:ext>
              </a:extLst>
            </p:cNvPr>
            <p:cNvSpPr/>
            <p:nvPr/>
          </p:nvSpPr>
          <p:spPr>
            <a:xfrm>
              <a:off x="3179167" y="4888508"/>
              <a:ext cx="1800000" cy="1800000"/>
            </a:xfrm>
            <a:prstGeom prst="ellipse">
              <a:avLst/>
            </a:prstGeom>
            <a:solidFill>
              <a:schemeClr val="bg2">
                <a:lumMod val="7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직사각형 184">
              <a:extLst>
                <a:ext uri="{FF2B5EF4-FFF2-40B4-BE49-F238E27FC236}">
                  <a16:creationId xmlns:a16="http://schemas.microsoft.com/office/drawing/2014/main" id="{97C4BDF2-4FFB-4682-8597-5A323B9A0D97}"/>
                </a:ext>
              </a:extLst>
            </p:cNvPr>
            <p:cNvSpPr/>
            <p:nvPr/>
          </p:nvSpPr>
          <p:spPr>
            <a:xfrm>
              <a:off x="5411392" y="4868286"/>
              <a:ext cx="1800000" cy="1800000"/>
            </a:xfrm>
            <a:prstGeom prst="rect">
              <a:avLst/>
            </a:prstGeom>
            <a:solidFill>
              <a:schemeClr val="bg2">
                <a:lumMod val="7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다이아몬드 185">
              <a:extLst>
                <a:ext uri="{FF2B5EF4-FFF2-40B4-BE49-F238E27FC236}">
                  <a16:creationId xmlns:a16="http://schemas.microsoft.com/office/drawing/2014/main" id="{7EC0C462-CA27-4425-B3E2-D4ED9644D6AB}"/>
                </a:ext>
              </a:extLst>
            </p:cNvPr>
            <p:cNvSpPr/>
            <p:nvPr/>
          </p:nvSpPr>
          <p:spPr>
            <a:xfrm>
              <a:off x="3726705" y="4686260"/>
              <a:ext cx="2780552" cy="2160000"/>
            </a:xfrm>
            <a:prstGeom prst="diamond">
              <a:avLst/>
            </a:prstGeom>
            <a:solidFill>
              <a:schemeClr val="bg2">
                <a:lumMod val="75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819A1E6A-1960-4C2D-A206-58AE333DDB90}"/>
                </a:ext>
              </a:extLst>
            </p:cNvPr>
            <p:cNvSpPr txBox="1"/>
            <p:nvPr/>
          </p:nvSpPr>
          <p:spPr>
            <a:xfrm>
              <a:off x="3178410" y="5568157"/>
              <a:ext cx="577324" cy="36121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pPr algn="ctr"/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ko-KR" sz="1600" kern="1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–</a:t>
              </a:r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ko-KR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FBAA6742-8B8C-4711-9DA9-E956968838ED}"/>
                </a:ext>
              </a:extLst>
            </p:cNvPr>
            <p:cNvSpPr txBox="1"/>
            <p:nvPr/>
          </p:nvSpPr>
          <p:spPr>
            <a:xfrm>
              <a:off x="5509870" y="5657949"/>
              <a:ext cx="1128013" cy="36121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pPr algn="ctr"/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Reversed coded)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C32720C2-A196-4514-AC7E-6C83787CF67E}"/>
                </a:ext>
              </a:extLst>
            </p:cNvPr>
            <p:cNvSpPr txBox="1"/>
            <p:nvPr/>
          </p:nvSpPr>
          <p:spPr>
            <a:xfrm>
              <a:off x="4047113" y="5568157"/>
              <a:ext cx="1027557" cy="54079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pPr algn="ctr"/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r>
                <a:rPr lang="en-US" altLang="ko-KR" sz="1600" kern="1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–</a:t>
              </a:r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Reverse coded)</a:t>
              </a:r>
            </a:p>
          </p:txBody>
        </p:sp>
        <p:sp>
          <p:nvSpPr>
            <p:cNvPr id="200" name="직사각형 13">
              <a:extLst>
                <a:ext uri="{FF2B5EF4-FFF2-40B4-BE49-F238E27FC236}">
                  <a16:creationId xmlns:a16="http://schemas.microsoft.com/office/drawing/2014/main" id="{8CD1297A-03D0-4F7E-9DCB-7DCEF198AF27}"/>
                </a:ext>
              </a:extLst>
            </p:cNvPr>
            <p:cNvSpPr/>
            <p:nvPr/>
          </p:nvSpPr>
          <p:spPr>
            <a:xfrm>
              <a:off x="3470383" y="4711668"/>
              <a:ext cx="936000" cy="270431"/>
            </a:xfrm>
            <a:prstGeom prst="round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1</a:t>
              </a:r>
              <a:endParaRPr lang="ko-KR" alt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직사각형 13">
              <a:extLst>
                <a:ext uri="{FF2B5EF4-FFF2-40B4-BE49-F238E27FC236}">
                  <a16:creationId xmlns:a16="http://schemas.microsoft.com/office/drawing/2014/main" id="{CBB4822C-535B-4A55-A6D2-DF2120032F11}"/>
                </a:ext>
              </a:extLst>
            </p:cNvPr>
            <p:cNvSpPr/>
            <p:nvPr/>
          </p:nvSpPr>
          <p:spPr>
            <a:xfrm>
              <a:off x="4662960" y="4710375"/>
              <a:ext cx="936000" cy="270431"/>
            </a:xfrm>
            <a:prstGeom prst="round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2</a:t>
              </a:r>
              <a:endParaRPr lang="ko-KR" alt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직사각형 13">
              <a:extLst>
                <a:ext uri="{FF2B5EF4-FFF2-40B4-BE49-F238E27FC236}">
                  <a16:creationId xmlns:a16="http://schemas.microsoft.com/office/drawing/2014/main" id="{6FC046F9-27C3-4C22-8E16-3D1CD681FB61}"/>
                </a:ext>
              </a:extLst>
            </p:cNvPr>
            <p:cNvSpPr/>
            <p:nvPr/>
          </p:nvSpPr>
          <p:spPr>
            <a:xfrm>
              <a:off x="5831097" y="4733070"/>
              <a:ext cx="936000" cy="270431"/>
            </a:xfrm>
            <a:prstGeom prst="round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3</a:t>
              </a:r>
              <a:endParaRPr lang="ko-KR" alt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0" name="그룹 49">
              <a:extLst>
                <a:ext uri="{FF2B5EF4-FFF2-40B4-BE49-F238E27FC236}">
                  <a16:creationId xmlns:a16="http://schemas.microsoft.com/office/drawing/2014/main" id="{5E2E98A7-C6E5-4294-B680-5A1E0F6F623E}"/>
                </a:ext>
              </a:extLst>
            </p:cNvPr>
            <p:cNvGrpSpPr/>
            <p:nvPr/>
          </p:nvGrpSpPr>
          <p:grpSpPr>
            <a:xfrm>
              <a:off x="1737121" y="-1125084"/>
              <a:ext cx="361833" cy="8015103"/>
              <a:chOff x="1419621" y="-1125084"/>
              <a:chExt cx="361833" cy="8015103"/>
            </a:xfrm>
          </p:grpSpPr>
          <p:grpSp>
            <p:nvGrpSpPr>
              <p:cNvPr id="10" name="그룹 9">
                <a:extLst>
                  <a:ext uri="{FF2B5EF4-FFF2-40B4-BE49-F238E27FC236}">
                    <a16:creationId xmlns:a16="http://schemas.microsoft.com/office/drawing/2014/main" id="{F6C89890-8D1B-4782-BD95-672D22CE3A7E}"/>
                  </a:ext>
                </a:extLst>
              </p:cNvPr>
              <p:cNvGrpSpPr/>
              <p:nvPr/>
            </p:nvGrpSpPr>
            <p:grpSpPr>
              <a:xfrm>
                <a:off x="1421454" y="615134"/>
                <a:ext cx="360000" cy="3321863"/>
                <a:chOff x="1081330" y="-324509"/>
                <a:chExt cx="360000" cy="3778586"/>
              </a:xfrm>
            </p:grpSpPr>
            <p:cxnSp>
              <p:nvCxnSpPr>
                <p:cNvPr id="7" name="직선 연결선 6">
                  <a:extLst>
                    <a:ext uri="{FF2B5EF4-FFF2-40B4-BE49-F238E27FC236}">
                      <a16:creationId xmlns:a16="http://schemas.microsoft.com/office/drawing/2014/main" id="{DAA035F3-62A1-44FC-B458-FA2646F67D15}"/>
                    </a:ext>
                  </a:extLst>
                </p:cNvPr>
                <p:cNvCxnSpPr/>
                <p:nvPr/>
              </p:nvCxnSpPr>
              <p:spPr>
                <a:xfrm>
                  <a:off x="1081330" y="-324508"/>
                  <a:ext cx="360000" cy="0"/>
                </a:xfrm>
                <a:prstGeom prst="line">
                  <a:avLst/>
                </a:prstGeom>
                <a:ln w="28575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직선 연결선 101">
                  <a:extLst>
                    <a:ext uri="{FF2B5EF4-FFF2-40B4-BE49-F238E27FC236}">
                      <a16:creationId xmlns:a16="http://schemas.microsoft.com/office/drawing/2014/main" id="{6F4C4287-71F5-42AC-BDDE-09BD434D9E08}"/>
                    </a:ext>
                  </a:extLst>
                </p:cNvPr>
                <p:cNvCxnSpPr/>
                <p:nvPr/>
              </p:nvCxnSpPr>
              <p:spPr>
                <a:xfrm>
                  <a:off x="1081330" y="3454077"/>
                  <a:ext cx="360000" cy="0"/>
                </a:xfrm>
                <a:prstGeom prst="line">
                  <a:avLst/>
                </a:prstGeom>
                <a:ln w="28575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직선 연결선 8">
                  <a:extLst>
                    <a:ext uri="{FF2B5EF4-FFF2-40B4-BE49-F238E27FC236}">
                      <a16:creationId xmlns:a16="http://schemas.microsoft.com/office/drawing/2014/main" id="{022687CE-4529-43F4-BBB8-6924745D5068}"/>
                    </a:ext>
                  </a:extLst>
                </p:cNvPr>
                <p:cNvCxnSpPr/>
                <p:nvPr/>
              </p:nvCxnSpPr>
              <p:spPr>
                <a:xfrm>
                  <a:off x="1270000" y="-324509"/>
                  <a:ext cx="0" cy="3767367"/>
                </a:xfrm>
                <a:prstGeom prst="line">
                  <a:avLst/>
                </a:prstGeom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3" name="그룹 152">
                <a:extLst>
                  <a:ext uri="{FF2B5EF4-FFF2-40B4-BE49-F238E27FC236}">
                    <a16:creationId xmlns:a16="http://schemas.microsoft.com/office/drawing/2014/main" id="{AAA33BDE-09E8-4507-9CF4-E15A4D1DA5D1}"/>
                  </a:ext>
                </a:extLst>
              </p:cNvPr>
              <p:cNvGrpSpPr/>
              <p:nvPr/>
            </p:nvGrpSpPr>
            <p:grpSpPr>
              <a:xfrm>
                <a:off x="1419621" y="-1125084"/>
                <a:ext cx="360000" cy="1685024"/>
                <a:chOff x="1081330" y="-324508"/>
                <a:chExt cx="360000" cy="3114064"/>
              </a:xfrm>
            </p:grpSpPr>
            <p:cxnSp>
              <p:nvCxnSpPr>
                <p:cNvPr id="154" name="직선 연결선 153">
                  <a:extLst>
                    <a:ext uri="{FF2B5EF4-FFF2-40B4-BE49-F238E27FC236}">
                      <a16:creationId xmlns:a16="http://schemas.microsoft.com/office/drawing/2014/main" id="{72A9B28F-78FB-43C8-84F2-DAF56C5A002E}"/>
                    </a:ext>
                  </a:extLst>
                </p:cNvPr>
                <p:cNvCxnSpPr/>
                <p:nvPr/>
              </p:nvCxnSpPr>
              <p:spPr>
                <a:xfrm>
                  <a:off x="1081330" y="-324508"/>
                  <a:ext cx="360000" cy="0"/>
                </a:xfrm>
                <a:prstGeom prst="line">
                  <a:avLst/>
                </a:prstGeom>
                <a:ln w="28575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직선 연결선 154">
                  <a:extLst>
                    <a:ext uri="{FF2B5EF4-FFF2-40B4-BE49-F238E27FC236}">
                      <a16:creationId xmlns:a16="http://schemas.microsoft.com/office/drawing/2014/main" id="{C57E99A5-A2C9-44C7-8EF3-C4E532BC4827}"/>
                    </a:ext>
                  </a:extLst>
                </p:cNvPr>
                <p:cNvCxnSpPr/>
                <p:nvPr/>
              </p:nvCxnSpPr>
              <p:spPr>
                <a:xfrm>
                  <a:off x="1081330" y="2789556"/>
                  <a:ext cx="360000" cy="0"/>
                </a:xfrm>
                <a:prstGeom prst="line">
                  <a:avLst/>
                </a:prstGeom>
                <a:ln w="28575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직선 연결선 155">
                  <a:extLst>
                    <a:ext uri="{FF2B5EF4-FFF2-40B4-BE49-F238E27FC236}">
                      <a16:creationId xmlns:a16="http://schemas.microsoft.com/office/drawing/2014/main" id="{02B36A06-2FD1-45EB-9BB8-C1B9133F7FF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70000" y="-324508"/>
                  <a:ext cx="0" cy="3114064"/>
                </a:xfrm>
                <a:prstGeom prst="line">
                  <a:avLst/>
                </a:prstGeom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3" name="그룹 202">
                <a:extLst>
                  <a:ext uri="{FF2B5EF4-FFF2-40B4-BE49-F238E27FC236}">
                    <a16:creationId xmlns:a16="http://schemas.microsoft.com/office/drawing/2014/main" id="{5D9F0136-D1A0-43E1-B41A-7EB5A69D0E52}"/>
                  </a:ext>
                </a:extLst>
              </p:cNvPr>
              <p:cNvGrpSpPr/>
              <p:nvPr/>
            </p:nvGrpSpPr>
            <p:grpSpPr>
              <a:xfrm>
                <a:off x="1419621" y="3984620"/>
                <a:ext cx="360000" cy="2905399"/>
                <a:chOff x="1081330" y="-356584"/>
                <a:chExt cx="360000" cy="2446044"/>
              </a:xfrm>
            </p:grpSpPr>
            <p:cxnSp>
              <p:nvCxnSpPr>
                <p:cNvPr id="204" name="직선 연결선 203">
                  <a:extLst>
                    <a:ext uri="{FF2B5EF4-FFF2-40B4-BE49-F238E27FC236}">
                      <a16:creationId xmlns:a16="http://schemas.microsoft.com/office/drawing/2014/main" id="{77D20097-26B9-4383-B6AB-B8E02D088AFD}"/>
                    </a:ext>
                  </a:extLst>
                </p:cNvPr>
                <p:cNvCxnSpPr/>
                <p:nvPr/>
              </p:nvCxnSpPr>
              <p:spPr>
                <a:xfrm>
                  <a:off x="1081330" y="-356584"/>
                  <a:ext cx="360000" cy="0"/>
                </a:xfrm>
                <a:prstGeom prst="line">
                  <a:avLst/>
                </a:prstGeom>
                <a:ln w="28575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5" name="직선 연결선 204">
                  <a:extLst>
                    <a:ext uri="{FF2B5EF4-FFF2-40B4-BE49-F238E27FC236}">
                      <a16:creationId xmlns:a16="http://schemas.microsoft.com/office/drawing/2014/main" id="{B58A054D-3B73-49DB-8977-81CC3330EAB0}"/>
                    </a:ext>
                  </a:extLst>
                </p:cNvPr>
                <p:cNvCxnSpPr/>
                <p:nvPr/>
              </p:nvCxnSpPr>
              <p:spPr>
                <a:xfrm>
                  <a:off x="1081330" y="2083881"/>
                  <a:ext cx="360000" cy="0"/>
                </a:xfrm>
                <a:prstGeom prst="line">
                  <a:avLst/>
                </a:prstGeom>
                <a:ln w="28575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6" name="직선 연결선 205">
                  <a:extLst>
                    <a:ext uri="{FF2B5EF4-FFF2-40B4-BE49-F238E27FC236}">
                      <a16:creationId xmlns:a16="http://schemas.microsoft.com/office/drawing/2014/main" id="{67F9C48C-7AA1-4FDC-A755-DD978DDC7393}"/>
                    </a:ext>
                  </a:extLst>
                </p:cNvPr>
                <p:cNvCxnSpPr/>
                <p:nvPr/>
              </p:nvCxnSpPr>
              <p:spPr>
                <a:xfrm>
                  <a:off x="1270000" y="-335200"/>
                  <a:ext cx="0" cy="2424660"/>
                </a:xfrm>
                <a:prstGeom prst="line">
                  <a:avLst/>
                </a:prstGeom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6023335B-05F2-4C30-A1AB-2B6A68352081}"/>
                </a:ext>
              </a:extLst>
            </p:cNvPr>
            <p:cNvSpPr txBox="1"/>
            <p:nvPr/>
          </p:nvSpPr>
          <p:spPr>
            <a:xfrm>
              <a:off x="562830" y="-457324"/>
              <a:ext cx="1354291" cy="33496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ctr">
              <a:noAutofit/>
            </a:bodyPr>
            <a:lstStyle/>
            <a:p>
              <a:pPr algn="r"/>
              <a:r>
                <a:rPr lang="en-US" altLang="ko-KR" sz="16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First phase</a:t>
              </a:r>
              <a:endParaRPr lang="ko-KR" altLang="en-US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CD55B917-83D0-4086-BA84-5314F14E2368}"/>
                </a:ext>
              </a:extLst>
            </p:cNvPr>
            <p:cNvSpPr txBox="1"/>
            <p:nvPr/>
          </p:nvSpPr>
          <p:spPr>
            <a:xfrm>
              <a:off x="562830" y="2002736"/>
              <a:ext cx="1354291" cy="33496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ctr">
              <a:noAutofit/>
            </a:bodyPr>
            <a:lstStyle/>
            <a:p>
              <a:pPr algn="r"/>
              <a:r>
                <a:rPr lang="en-US" altLang="ko-KR" sz="16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Second phase</a:t>
              </a:r>
              <a:endParaRPr lang="ko-KR" altLang="en-US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48E11C93-716D-4885-9C6D-FCA5BDC50998}"/>
                </a:ext>
              </a:extLst>
            </p:cNvPr>
            <p:cNvSpPr txBox="1"/>
            <p:nvPr/>
          </p:nvSpPr>
          <p:spPr>
            <a:xfrm>
              <a:off x="562830" y="5304867"/>
              <a:ext cx="1354291" cy="33496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ctr">
              <a:noAutofit/>
            </a:bodyPr>
            <a:lstStyle/>
            <a:p>
              <a:pPr algn="r"/>
              <a:r>
                <a:rPr lang="en-US" altLang="ko-KR" sz="16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Third phase</a:t>
              </a:r>
              <a:endParaRPr lang="ko-KR" altLang="en-US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1" name="직선 화살표 연결선 150">
              <a:extLst>
                <a:ext uri="{FF2B5EF4-FFF2-40B4-BE49-F238E27FC236}">
                  <a16:creationId xmlns:a16="http://schemas.microsoft.com/office/drawing/2014/main" id="{B4799BE5-56CD-4E05-946B-6C218A735495}"/>
                </a:ext>
              </a:extLst>
            </p:cNvPr>
            <p:cNvCxnSpPr>
              <a:cxnSpLocks/>
            </p:cNvCxnSpPr>
            <p:nvPr/>
          </p:nvCxnSpPr>
          <p:spPr>
            <a:xfrm rot="5400000" flipH="1" flipV="1">
              <a:off x="5096126" y="4792643"/>
              <a:ext cx="15642" cy="4320000"/>
            </a:xfrm>
            <a:prstGeom prst="bentConnector3">
              <a:avLst>
                <a:gd name="adj1" fmla="val -2273367"/>
              </a:avLst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headEnd type="none" w="lg" len="med"/>
              <a:tailEnd type="non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2F6D9545-DBF3-42BD-8639-8CC0EDAF165E}"/>
                </a:ext>
              </a:extLst>
            </p:cNvPr>
            <p:cNvSpPr txBox="1"/>
            <p:nvPr/>
          </p:nvSpPr>
          <p:spPr>
            <a:xfrm>
              <a:off x="3103601" y="7821363"/>
              <a:ext cx="4320000" cy="37647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 anchor="ctr">
              <a:noAutofit/>
            </a:bodyPr>
            <a:lstStyle/>
            <a:p>
              <a:pPr algn="ct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16 items are synthesized as a single-dimensional attitude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화살표: 아래쪽 1">
              <a:extLst>
                <a:ext uri="{FF2B5EF4-FFF2-40B4-BE49-F238E27FC236}">
                  <a16:creationId xmlns:a16="http://schemas.microsoft.com/office/drawing/2014/main" id="{17EE749B-E0AC-4369-96B4-A9A9862F5E63}"/>
                </a:ext>
              </a:extLst>
            </p:cNvPr>
            <p:cNvSpPr/>
            <p:nvPr/>
          </p:nvSpPr>
          <p:spPr>
            <a:xfrm>
              <a:off x="4925241" y="7311523"/>
              <a:ext cx="360000" cy="540000"/>
            </a:xfrm>
            <a:prstGeom prst="down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8732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1</TotalTime>
  <Words>87</Words>
  <Application>Microsoft Office PowerPoint</Application>
  <PresentationFormat>와이드스크린</PresentationFormat>
  <Paragraphs>28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un</dc:creator>
  <cp:lastModifiedBy>hyun</cp:lastModifiedBy>
  <cp:revision>75</cp:revision>
  <dcterms:created xsi:type="dcterms:W3CDTF">2023-03-11T09:16:00Z</dcterms:created>
  <dcterms:modified xsi:type="dcterms:W3CDTF">2023-11-01T03:37:51Z</dcterms:modified>
</cp:coreProperties>
</file>